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1F8DE-9DBC-4696-907A-85BBA79CB0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56CE2-4573-447F-BEC8-7744AE15F2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9C620-AA8C-4012-A44A-B99EA48970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DF2DD-7DCE-4D29-8871-37405C20FC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E7BDC-8E04-44C5-AB23-5D8108C086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17C06-C37B-4E8C-97E2-1896C8ACEF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308190-0977-4A5B-9CD7-A1BE1F20FE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A8768-BF81-43A0-B9A3-D6B36A3C20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D5454-64E9-4F74-AB2D-7B3F8FF77E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84B3B-DEB7-4855-A554-5D497A8952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CDEAA-F72E-45AA-8CB5-D2CB00956B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7EE252-13B6-45FE-B5B6-AD40CC9378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80A765-793C-44DC-A0FF-FB66B32F69A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85800" y="380880"/>
          <a:ext cx="5334120" cy="2068560"/>
        </p:xfrm>
        <a:graphic>
          <a:graphicData uri="http://schemas.openxmlformats.org/drawingml/2006/table">
            <a:tbl>
              <a:tblPr/>
              <a:tblGrid>
                <a:gridCol w="711360"/>
                <a:gridCol w="2149200"/>
                <a:gridCol w="939960"/>
                <a:gridCol w="708120"/>
                <a:gridCol w="825480"/>
              </a:tblGrid>
              <a:tr h="149040">
                <a:tc rowSpan="2"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iGene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tokine / Receptor Subun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lated cytokin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igene 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20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uma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5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u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6280">
                <a:tc gridSpan="5"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-35 recept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6280">
                <a:tc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12RB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erleukin 12 receptor, beta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. 4793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. 1883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6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erleukin 6 signal transduc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. 53208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. 43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6280">
                <a:tc gridSpan="5"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-10 and TGF-</a:t>
                      </a:r>
                      <a:r>
                        <a:rPr b="0" lang="el-G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recept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6280">
                <a:tc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10R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erleukin 10 receptor, alph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. 5040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. 3793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10R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erleukin 10 receptor, bet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. 6545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. 41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FB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nsforming growth factor, beta receptor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F</a:t>
                      </a:r>
                      <a:r>
                        <a:rPr b="0" lang="el-G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. 4946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. 1975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anchor="ctr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FB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nsforming growth factor, beta receptor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. 820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. 1723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 Box 4"/>
          <p:cNvSpPr/>
          <p:nvPr/>
        </p:nvSpPr>
        <p:spPr>
          <a:xfrm>
            <a:off x="696960" y="114480"/>
            <a:ext cx="37908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PGothic"/>
              </a:rPr>
              <a:t>Table S1. The Unigene ID of human and mouse genes that were examined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Nemo</cp:lastModifiedBy>
  <dcterms:modified xsi:type="dcterms:W3CDTF">2012-02-20T15:27:21Z</dcterms:modified>
  <cp:revision>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